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38F3B-8802-4A6F-AB26-97794F93E1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61839-E800-4338-8C21-17B52B37D8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E1809-6AC0-4E2E-BA52-102F3948D1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924EA-C2EC-40DA-9C86-0F8187BE59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B72D6-5B2F-4E1C-8073-0DB9112852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00DD5-12E6-4720-A3C9-4963746A0A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B7457-3338-499E-B4DB-98CB7EB04B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49B85-EA5E-45B2-959A-F92DDC63CE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96A38-6198-455D-B3F0-5807676D5A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F3032-AAD5-4476-8A22-99483BFED3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11CF3-FD11-42B5-85EF-A5153624C7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2BA94-191C-4AB1-AB39-8296E7C274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58E905-EB51-4F7D-93F7-2231A1830B98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57200" y="981000"/>
          <a:ext cx="8229600" cy="3110040"/>
        </p:xfrm>
        <a:graphic>
          <a:graphicData uri="http://schemas.openxmlformats.org/drawingml/2006/table">
            <a:tbl>
              <a:tblPr/>
              <a:tblGrid>
                <a:gridCol w="1521000"/>
                <a:gridCol w="3311280"/>
                <a:gridCol w="3397320"/>
              </a:tblGrid>
              <a:tr h="336600">
                <a:tc gridSpan="3"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ble S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CR-based molecular markers designed for fine mappi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5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rk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 primer (5’→3’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primer (5’→3’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GAGGCTAGGGAGGAAACAT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AAGAACGGGCTCAACCAAG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GGTTGGGGAGGTGTGTT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CAGATTGCGAGATCGACC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TTGCCTTGTGCCGTTG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GGACAGAGCCCGTTTAA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GGGGAAGAATAACGGGA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ACCACTACCCCAACG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ACCTCGTCTTTGAGCCCA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GCCGCAAAATGAGCTCTAC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TCATCCTGTCGCCAAC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TGGATGCGTGATGCG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ACCAGTCTACAGCCACATC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AGGGCGTATTTTCAGCGTC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CCCAGAGCAAACTGTCA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AACTGTACGTTTCCCCC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Administrator</dc:creator>
  <dc:description/>
  <cp:keywords/>
  <dc:language>en-US</dc:language>
  <cp:lastModifiedBy>微软用户</cp:lastModifiedBy>
  <dcterms:modified xsi:type="dcterms:W3CDTF">2014-12-07T14:05:36Z</dcterms:modified>
  <cp:revision>13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468</vt:lpwstr>
  </property>
</Properties>
</file>